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5664" userDrawn="1">
          <p15:clr>
            <a:srgbClr val="A4A3A4"/>
          </p15:clr>
        </p15:guide>
        <p15:guide id="3" orient="horz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957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1962" y="108"/>
      </p:cViewPr>
      <p:guideLst>
        <p:guide pos="5664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4E193-C831-4550-9D00-2ABCBCF9582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71799-D4F1-47B4-8C37-17E8F133A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078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4E193-C831-4550-9D00-2ABCBCF9582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71799-D4F1-47B4-8C37-17E8F133A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105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365125"/>
            <a:ext cx="1478756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365125"/>
            <a:ext cx="432196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4E193-C831-4550-9D00-2ABCBCF9582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71799-D4F1-47B4-8C37-17E8F133A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8890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4E193-C831-4550-9D00-2ABCBCF9582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71799-D4F1-47B4-8C37-17E8F133A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2499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4E193-C831-4550-9D00-2ABCBCF9582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71799-D4F1-47B4-8C37-17E8F133A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6661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7" y="1825625"/>
            <a:ext cx="2900363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1825625"/>
            <a:ext cx="2900363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4E193-C831-4550-9D00-2ABCBCF9582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71799-D4F1-47B4-8C37-17E8F133A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614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4E193-C831-4550-9D00-2ABCBCF9582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71799-D4F1-47B4-8C37-17E8F133A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417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4E193-C831-4550-9D00-2ABCBCF9582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71799-D4F1-47B4-8C37-17E8F133A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994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4E193-C831-4550-9D00-2ABCBCF9582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71799-D4F1-47B4-8C37-17E8F133A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743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4E193-C831-4550-9D00-2ABCBCF9582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71799-D4F1-47B4-8C37-17E8F133A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581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4E193-C831-4550-9D00-2ABCBCF9582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71799-D4F1-47B4-8C37-17E8F133A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305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4E193-C831-4550-9D00-2ABCBCF9582A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71799-D4F1-47B4-8C37-17E8F133AE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2590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3665" y="436855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MT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13665" y="3621099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MT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2" name="Picture 15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07" b="4818"/>
          <a:stretch/>
        </p:blipFill>
        <p:spPr>
          <a:xfrm>
            <a:off x="665169" y="4822032"/>
            <a:ext cx="1017234" cy="15727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3" name="Picture 15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98" b="3445"/>
          <a:stretch/>
        </p:blipFill>
        <p:spPr>
          <a:xfrm>
            <a:off x="1689338" y="4822032"/>
            <a:ext cx="1125060" cy="15727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5" name="Picture 15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19" b="-1"/>
          <a:stretch/>
        </p:blipFill>
        <p:spPr>
          <a:xfrm>
            <a:off x="3830339" y="4822032"/>
            <a:ext cx="989335" cy="15727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6" name="Picture 155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400" b="3030"/>
          <a:stretch/>
        </p:blipFill>
        <p:spPr>
          <a:xfrm>
            <a:off x="5794331" y="4822032"/>
            <a:ext cx="997304" cy="157276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8" name="TextBox 157"/>
          <p:cNvSpPr txBox="1"/>
          <p:nvPr/>
        </p:nvSpPr>
        <p:spPr>
          <a:xfrm rot="16200000">
            <a:off x="942509" y="4297056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 rot="16200000">
            <a:off x="1122469" y="4297056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 rot="16200000">
            <a:off x="445725" y="4179235"/>
            <a:ext cx="1122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IM9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 rot="16200000">
            <a:off x="621649" y="4172823"/>
            <a:ext cx="11352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BL2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 rot="16200000">
            <a:off x="1963551" y="4297056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 rot="16200000">
            <a:off x="2181609" y="4297056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 rot="16200000">
            <a:off x="1416756" y="4179235"/>
            <a:ext cx="1122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IM9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/>
          <p:cNvSpPr txBox="1"/>
          <p:nvPr/>
        </p:nvSpPr>
        <p:spPr>
          <a:xfrm rot="16200000">
            <a:off x="1618876" y="4172823"/>
            <a:ext cx="11352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BL2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 rot="16200000">
            <a:off x="3031727" y="4297056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 rot="16200000">
            <a:off x="3235022" y="4297056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 rot="16200000">
            <a:off x="2533510" y="4179235"/>
            <a:ext cx="1122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IM9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/>
          <p:cNvSpPr txBox="1"/>
          <p:nvPr/>
        </p:nvSpPr>
        <p:spPr>
          <a:xfrm rot="16200000">
            <a:off x="2726107" y="4172823"/>
            <a:ext cx="11352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BL2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 rot="16200000">
            <a:off x="4049676" y="4297056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 rot="16200000">
            <a:off x="4253446" y="4297056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 rot="16200000">
            <a:off x="3560032" y="4179235"/>
            <a:ext cx="1122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IM9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/>
          <p:cNvSpPr txBox="1"/>
          <p:nvPr/>
        </p:nvSpPr>
        <p:spPr>
          <a:xfrm rot="16200000">
            <a:off x="3745482" y="4172823"/>
            <a:ext cx="11352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BL2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 rot="16200000">
            <a:off x="5969004" y="4297056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 rot="16200000">
            <a:off x="6167060" y="4297056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/>
          <p:cNvSpPr txBox="1"/>
          <p:nvPr/>
        </p:nvSpPr>
        <p:spPr>
          <a:xfrm rot="16200000">
            <a:off x="5467456" y="4179235"/>
            <a:ext cx="1122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IM9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/>
          <p:cNvSpPr txBox="1"/>
          <p:nvPr/>
        </p:nvSpPr>
        <p:spPr>
          <a:xfrm rot="16200000">
            <a:off x="5656721" y="4172823"/>
            <a:ext cx="11352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BL2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 rot="16200000">
            <a:off x="7016859" y="4297056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 rot="16200000">
            <a:off x="7230155" y="4297056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 rot="16200000">
            <a:off x="6505785" y="4179235"/>
            <a:ext cx="1122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IM9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 rot="16200000">
            <a:off x="6686474" y="4172823"/>
            <a:ext cx="11352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BL2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263980" y="485992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/>
          <p:cNvSpPr txBox="1"/>
          <p:nvPr/>
        </p:nvSpPr>
        <p:spPr>
          <a:xfrm>
            <a:off x="263980" y="4939111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>
            <a:off x="263980" y="5031753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315276" y="5150803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315276" y="5333288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315276" y="5525551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315276" y="5830751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/>
          <p:cNvSpPr txBox="1"/>
          <p:nvPr/>
        </p:nvSpPr>
        <p:spPr>
          <a:xfrm>
            <a:off x="315276" y="6014193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794773" y="6370978"/>
            <a:ext cx="7889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/>
          <p:cNvSpPr txBox="1"/>
          <p:nvPr/>
        </p:nvSpPr>
        <p:spPr>
          <a:xfrm>
            <a:off x="1743801" y="6370978"/>
            <a:ext cx="10038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ouse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ti-NMT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4089816" y="6370978"/>
            <a:ext cx="5483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G1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TextBox 193"/>
          <p:cNvSpPr txBox="1"/>
          <p:nvPr/>
        </p:nvSpPr>
        <p:spPr>
          <a:xfrm>
            <a:off x="6060387" y="6370978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C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 rot="16200000">
            <a:off x="5008630" y="4297056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 rot="16200000">
            <a:off x="5221926" y="4297056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 rot="16200000">
            <a:off x="4497556" y="4179235"/>
            <a:ext cx="1122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IM9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 rot="16200000">
            <a:off x="4678245" y="4172823"/>
            <a:ext cx="11352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BL2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3055663" y="6370978"/>
            <a:ext cx="474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G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5034296" y="6370978"/>
            <a:ext cx="5597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G1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7093804" y="6370978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D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29" b="20547"/>
          <a:stretch/>
        </p:blipFill>
        <p:spPr>
          <a:xfrm>
            <a:off x="2827971" y="4822032"/>
            <a:ext cx="997840" cy="15727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539" b="20220"/>
          <a:stretch/>
        </p:blipFill>
        <p:spPr>
          <a:xfrm>
            <a:off x="4798531" y="4822032"/>
            <a:ext cx="1015264" cy="15727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71" b="23448"/>
          <a:stretch/>
        </p:blipFill>
        <p:spPr>
          <a:xfrm>
            <a:off x="6800104" y="4822032"/>
            <a:ext cx="1046048" cy="15727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9" t="15252" r="2713" b="21409"/>
          <a:stretch/>
        </p:blipFill>
        <p:spPr>
          <a:xfrm>
            <a:off x="5464787" y="1656202"/>
            <a:ext cx="1146153" cy="13350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1" name="Picture 5" descr="C:\Users\Luc\Desktop\NMT1 top lane.png"/>
          <p:cNvPicPr>
            <a:picLocks noChangeAspect="1" noChangeArrowheads="1"/>
          </p:cNvPicPr>
          <p:nvPr/>
        </p:nvPicPr>
        <p:blipFill rotWithShape="1">
          <a:blip r:embed="rId10" cstate="print"/>
          <a:srcRect l="50732" t="16517" r="26096" b="20288"/>
          <a:stretch/>
        </p:blipFill>
        <p:spPr bwMode="auto">
          <a:xfrm>
            <a:off x="6623246" y="1656202"/>
            <a:ext cx="1138036" cy="13350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15" b="2735"/>
          <a:stretch/>
        </p:blipFill>
        <p:spPr>
          <a:xfrm>
            <a:off x="3049372" y="1656202"/>
            <a:ext cx="1182123" cy="13350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39" b="6341"/>
          <a:stretch/>
        </p:blipFill>
        <p:spPr>
          <a:xfrm>
            <a:off x="1778817" y="1656202"/>
            <a:ext cx="1267843" cy="13350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82" r="5493" b="8787"/>
          <a:stretch/>
        </p:blipFill>
        <p:spPr>
          <a:xfrm>
            <a:off x="688140" y="1660107"/>
            <a:ext cx="1117662" cy="133111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/>
          <p:cNvSpPr txBox="1"/>
          <p:nvPr/>
        </p:nvSpPr>
        <p:spPr>
          <a:xfrm>
            <a:off x="852562" y="2968953"/>
            <a:ext cx="7889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966286" y="2968953"/>
            <a:ext cx="90120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oly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ti-NMT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428295" y="2968953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F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352036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 rot="16200000">
            <a:off x="572055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 rot="16200000">
            <a:off x="987030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16200000">
            <a:off x="1108478" y="1004724"/>
            <a:ext cx="1122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IM9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6200000">
            <a:off x="1493866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 rot="16200000">
            <a:off x="1735316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rot="16200000">
            <a:off x="2219348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6200000">
            <a:off x="2357464" y="1004724"/>
            <a:ext cx="1122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IM9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6200000">
            <a:off x="2755728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16200000">
            <a:off x="2963843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6200000">
            <a:off x="3419300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6200000">
            <a:off x="3550271" y="1004724"/>
            <a:ext cx="1122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IM9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283030" y="170515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283030" y="181976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283030" y="1929612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334326" y="2056114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334326" y="2307375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334326" y="2525409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71" t="17373" b="21091"/>
          <a:stretch/>
        </p:blipFill>
        <p:spPr>
          <a:xfrm>
            <a:off x="7782121" y="1656202"/>
            <a:ext cx="1146444" cy="13350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5" name="TextBox 114"/>
          <p:cNvSpPr txBox="1"/>
          <p:nvPr/>
        </p:nvSpPr>
        <p:spPr>
          <a:xfrm>
            <a:off x="6959668" y="2968953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9C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8122747" y="2968953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9C9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5800458" y="2968953"/>
            <a:ext cx="474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8G6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4614552" y="2968953"/>
            <a:ext cx="4571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E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5108297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5341806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5799650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5916333" y="1004724"/>
            <a:ext cx="1122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IM9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 rot="16200000">
            <a:off x="3909346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 rot="16200000">
            <a:off x="4146029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 rot="16200000">
            <a:off x="4625304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 rot="16200000">
            <a:off x="4761040" y="1004724"/>
            <a:ext cx="1122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IM9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 rot="16200000">
            <a:off x="6301550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 rot="16200000">
            <a:off x="6527239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 rot="16200000">
            <a:off x="6949272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 rot="16200000">
            <a:off x="7062567" y="1004724"/>
            <a:ext cx="1122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IM9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 rot="16200000">
            <a:off x="7440075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 rot="16200000">
            <a:off x="7683992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 rot="16200000">
            <a:off x="8136095" y="1122545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 ng NMT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 rot="16200000">
            <a:off x="8251034" y="1004724"/>
            <a:ext cx="1122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 µg IM9 lysat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2" name="Picture 2" descr="C:\Users\Luc\Desktop\Bottom lane.png"/>
          <p:cNvPicPr>
            <a:picLocks noChangeAspect="1" noChangeArrowheads="1"/>
          </p:cNvPicPr>
          <p:nvPr/>
        </p:nvPicPr>
        <p:blipFill rotWithShape="1">
          <a:blip r:embed="rId15" cstate="print"/>
          <a:srcRect l="1" t="16717" r="77063" b="24988"/>
          <a:stretch/>
        </p:blipFill>
        <p:spPr bwMode="auto">
          <a:xfrm>
            <a:off x="4239466" y="1656202"/>
            <a:ext cx="1211458" cy="13350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06" name="TextBox 105"/>
          <p:cNvSpPr txBox="1"/>
          <p:nvPr/>
        </p:nvSpPr>
        <p:spPr>
          <a:xfrm>
            <a:off x="0" y="189353"/>
            <a:ext cx="182880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0" y="3329323"/>
            <a:ext cx="182880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44151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0</TotalTime>
  <Words>241</Words>
  <Application>Microsoft Office PowerPoint</Application>
  <PresentationFormat>On-screen Show (4:3)</PresentationFormat>
  <Paragraphs>9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Alberta Health Service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rissa Vos</dc:creator>
  <cp:lastModifiedBy>Larissa Vos</cp:lastModifiedBy>
  <cp:revision>25</cp:revision>
  <dcterms:created xsi:type="dcterms:W3CDTF">2020-01-02T18:04:46Z</dcterms:created>
  <dcterms:modified xsi:type="dcterms:W3CDTF">2020-02-18T22:10:47Z</dcterms:modified>
</cp:coreProperties>
</file>